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263"/>
    <p:restoredTop sz="94595"/>
  </p:normalViewPr>
  <p:slideViewPr>
    <p:cSldViewPr snapToGrid="0" snapToObjects="1">
      <p:cViewPr varScale="1">
        <p:scale>
          <a:sx n="76" d="100"/>
          <a:sy n="76" d="100"/>
        </p:scale>
        <p:origin x="261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0810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0987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214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4913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591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5549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549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3361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8465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0177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3265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2986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656000" y="5351493"/>
            <a:ext cx="3647440" cy="905256"/>
          </a:xfrm>
          <a:prstGeom prst="rect">
            <a:avLst/>
          </a:prstGeom>
        </p:spPr>
      </p:pic>
      <p:pic>
        <p:nvPicPr>
          <p:cNvPr id="24" name="Picture 2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655999" y="7089084"/>
            <a:ext cx="3647440" cy="905256"/>
          </a:xfrm>
          <a:prstGeom prst="rect">
            <a:avLst/>
          </a:prstGeom>
        </p:spPr>
      </p:pic>
      <p:pic>
        <p:nvPicPr>
          <p:cNvPr id="21" name="Picture 20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656000" y="4144370"/>
            <a:ext cx="3647440" cy="822960"/>
          </a:xfrm>
          <a:prstGeom prst="rect">
            <a:avLst/>
          </a:prstGeom>
        </p:spPr>
      </p:pic>
      <p:pic>
        <p:nvPicPr>
          <p:cNvPr id="19" name="Picture 18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657361" y="2668255"/>
            <a:ext cx="3647440" cy="1097280"/>
          </a:xfrm>
          <a:prstGeom prst="rect">
            <a:avLst/>
          </a:prstGeom>
        </p:spPr>
      </p:pic>
      <p:pic>
        <p:nvPicPr>
          <p:cNvPr id="17" name="Picture 1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1657440" y="698207"/>
            <a:ext cx="3647440" cy="54864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29370" y="278296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Figure 5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1568981" y="1141415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1852581" y="1370900"/>
            <a:ext cx="3319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YM155 IC</a:t>
            </a:r>
            <a:r>
              <a:rPr lang="en-GB" sz="1200" baseline="-25000" dirty="0">
                <a:latin typeface="Arial" charset="0"/>
                <a:ea typeface="Arial" charset="0"/>
                <a:cs typeface="Arial" charset="0"/>
              </a:rPr>
              <a:t>50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n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758460" y="930823"/>
            <a:ext cx="1111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doxorubicin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762002" y="696781"/>
            <a:ext cx="1111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etoposide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32913" y="668275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432000" y="1618655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4975923" y="2694189"/>
            <a:ext cx="3110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>
                <a:latin typeface="Arial" charset="0"/>
                <a:ea typeface="Arial" charset="0"/>
                <a:cs typeface="Arial" charset="0"/>
              </a:rPr>
              <a:t>1</a:t>
            </a:r>
            <a:endParaRPr lang="en-GB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2216055" y="1143915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>
                <a:latin typeface="Arial" charset="0"/>
                <a:ea typeface="Arial" charset="0"/>
                <a:cs typeface="Arial" charset="0"/>
              </a:rPr>
              <a:t>50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2878118" y="1138920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3532687" y="1141420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>
                <a:latin typeface="Arial" charset="0"/>
                <a:ea typeface="Arial" charset="0"/>
                <a:cs typeface="Arial" charset="0"/>
              </a:rPr>
              <a:t>150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4179760" y="1143920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4834328" y="1138925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250</a:t>
            </a:r>
          </a:p>
        </p:txBody>
      </p:sp>
      <p:pic>
        <p:nvPicPr>
          <p:cNvPr id="18" name="Picture 1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657361" y="1660177"/>
            <a:ext cx="3647440" cy="1097280"/>
          </a:xfrm>
          <a:prstGeom prst="rect">
            <a:avLst/>
          </a:prstGeom>
        </p:spPr>
      </p:pic>
      <p:sp>
        <p:nvSpPr>
          <p:cNvPr id="91" name="TextBox 90"/>
          <p:cNvSpPr txBox="1"/>
          <p:nvPr/>
        </p:nvSpPr>
        <p:spPr>
          <a:xfrm>
            <a:off x="764502" y="2055892"/>
            <a:ext cx="1111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etoposide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767002" y="3047740"/>
            <a:ext cx="1111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doxorubicin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1563986" y="3602302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1854000" y="3831787"/>
            <a:ext cx="3319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YM155 IC</a:t>
            </a:r>
            <a:r>
              <a:rPr lang="en-GB" sz="1200" baseline="-25000" dirty="0">
                <a:latin typeface="Arial" charset="0"/>
                <a:ea typeface="Arial" charset="0"/>
                <a:cs typeface="Arial" charset="0"/>
              </a:rPr>
              <a:t>50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n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2385948" y="3599807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3207902" y="3604807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4829333" y="3599812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4014873" y="3602312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300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432000" y="4117012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760960" y="4620911"/>
            <a:ext cx="1111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carboplatin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759600" y="4398561"/>
            <a:ext cx="1111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oxaliplatin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756000" y="4176211"/>
            <a:ext cx="1111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cisplatin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1558991" y="4833995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1849005" y="5063480"/>
            <a:ext cx="3319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YM155 IC</a:t>
            </a:r>
            <a:r>
              <a:rPr lang="en-GB" sz="1200" baseline="-25000" dirty="0">
                <a:latin typeface="Arial" charset="0"/>
                <a:ea typeface="Arial" charset="0"/>
                <a:cs typeface="Arial" charset="0"/>
              </a:rPr>
              <a:t>50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n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2500873" y="4831500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3427757" y="4836500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4824338" y="4831505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350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4362143" y="4834005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300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3894947" y="4835570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250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2977200" y="4835570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2026800" y="4835570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432000" y="5294715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759507" y="5641043"/>
            <a:ext cx="1111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cisplatin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762007" y="7382401"/>
            <a:ext cx="1111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carboplatin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1558991" y="7854518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2380953" y="7852023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3202907" y="7857023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4824338" y="7852028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4009878" y="7854528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300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1844010" y="8101497"/>
            <a:ext cx="3319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YM155 IC</a:t>
            </a:r>
            <a:r>
              <a:rPr lang="en-GB" sz="1200" baseline="-25000" dirty="0">
                <a:latin typeface="Arial" charset="0"/>
                <a:ea typeface="Arial" charset="0"/>
                <a:cs typeface="Arial" charset="0"/>
              </a:rPr>
              <a:t>50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n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pic>
        <p:nvPicPr>
          <p:cNvPr id="25" name="Picture 24"/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1656000" y="6221081"/>
            <a:ext cx="3647440" cy="905256"/>
          </a:xfrm>
          <a:prstGeom prst="rect">
            <a:avLst/>
          </a:prstGeom>
        </p:spPr>
      </p:pic>
      <p:sp>
        <p:nvSpPr>
          <p:cNvPr id="131" name="TextBox 130"/>
          <p:cNvSpPr txBox="1"/>
          <p:nvPr/>
        </p:nvSpPr>
        <p:spPr>
          <a:xfrm>
            <a:off x="764507" y="6515475"/>
            <a:ext cx="1111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oxaliplatin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506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53</TotalTime>
  <Words>61</Words>
  <Application>Microsoft Macintosh PowerPoint</Application>
  <PresentationFormat>On-screen Show (4:3)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Michaelis</dc:creator>
  <cp:lastModifiedBy>Microsoft Office User</cp:lastModifiedBy>
  <cp:revision>124</cp:revision>
  <dcterms:created xsi:type="dcterms:W3CDTF">2016-10-07T17:18:31Z</dcterms:created>
  <dcterms:modified xsi:type="dcterms:W3CDTF">2020-02-20T21:06:32Z</dcterms:modified>
</cp:coreProperties>
</file>